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1" r:id="rId2"/>
  </p:sldMasterIdLst>
  <p:notesMasterIdLst>
    <p:notesMasterId r:id="rId4"/>
  </p:notesMasterIdLst>
  <p:handoutMasterIdLst>
    <p:handoutMasterId r:id="rId5"/>
  </p:handoutMasterIdLst>
  <p:sldIdLst>
    <p:sldId id="258" r:id="rId3"/>
  </p:sldIdLst>
  <p:sldSz cx="9144000" cy="5143500" type="screen16x9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F3A1D0FB-34B5-4D3B-A823-46ED72478707}">
          <p14:sldIdLst>
            <p14:sldId id="258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rtha Banegas (CIRSE)" initials="MB(" lastIdx="1" clrIdx="0">
    <p:extLst>
      <p:ext uri="{19B8F6BF-5375-455C-9EA6-DF929625EA0E}">
        <p15:presenceInfo xmlns:p15="http://schemas.microsoft.com/office/powerpoint/2012/main" userId="S-1-5-21-2651319904-341586798-2033076253-4669" providerId="AD"/>
      </p:ext>
    </p:extLst>
  </p:cmAuthor>
  <p:cmAuthor id="2" name="Natasa Aleksic (CIRSE)" initials="NA(" lastIdx="2" clrIdx="1">
    <p:extLst>
      <p:ext uri="{19B8F6BF-5375-455C-9EA6-DF929625EA0E}">
        <p15:presenceInfo xmlns:p15="http://schemas.microsoft.com/office/powerpoint/2012/main" userId="S-1-5-21-2651319904-341586798-2033076253-9197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02A74"/>
    <a:srgbClr val="E6E0EC"/>
    <a:srgbClr val="B8B8B8"/>
    <a:srgbClr val="00CC99"/>
    <a:srgbClr val="66FF99"/>
    <a:srgbClr val="9999FF"/>
    <a:srgbClr val="FF99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256" autoAdjust="0"/>
  </p:normalViewPr>
  <p:slideViewPr>
    <p:cSldViewPr>
      <p:cViewPr varScale="1">
        <p:scale>
          <a:sx n="122" d="100"/>
          <a:sy n="122" d="100"/>
        </p:scale>
        <p:origin x="86" y="571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>
      <p:cViewPr varScale="1">
        <p:scale>
          <a:sx n="99" d="100"/>
          <a:sy n="99" d="100"/>
        </p:scale>
        <p:origin x="3570" y="84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handoutMaster" Target="handoutMasters/handoutMaster1.xml"/><Relationship Id="rId10" Type="http://schemas.openxmlformats.org/officeDocument/2006/relationships/tableStyles" Target="tableStyles.xml"/><Relationship Id="rId4" Type="http://schemas.openxmlformats.org/officeDocument/2006/relationships/notesMaster" Target="notesMasters/notesMaster1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C0409DFA-D775-ABE1-602E-F765AC07B833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B7E12AB-A52A-78E3-A531-6D5EEA44AB6D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D565E8-2268-47A3-B05E-B92E67ACABC2}" type="datetimeFigureOut">
              <a:rPr lang="en-GB" smtClean="0"/>
              <a:t>10/01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3324044-AFFA-2F0C-C21D-352599C23508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48FA006-6AED-5337-129A-4B266CD8F300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77BA527-8EE5-4F2D-B69F-8CFBED73D67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218099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2D1F91-D8AB-46A4-81BD-170C41F377DC}" type="datetimeFigureOut">
              <a:rPr lang="en-GB" smtClean="0"/>
              <a:t>10/01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7C6A211-0A36-4A8E-A9B2-175F54AAEA4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55706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7C6A211-0A36-4A8E-A9B2-175F54AAEA4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97578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651E-7EAF-4611-B03E-7082763CB9BE}" type="datetimeFigureOut">
              <a:rPr lang="de-AT" smtClean="0"/>
              <a:t>10.01.2024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EAECF-7086-45B2-8874-828A8139E49C}" type="slidenum">
              <a:rPr lang="de-AT" smtClean="0"/>
              <a:t>‹#›</a:t>
            </a:fld>
            <a:endParaRPr lang="de-AT"/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96601310-BCD2-46C1-95E9-73B7D29769B2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0" y="0"/>
            <a:ext cx="9144000" cy="714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81119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B3F4FB-CAFA-AB2A-331F-3064FE9EA2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9D6707-5D32-64F3-FB14-5EEBFAE78AC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304656-747E-7A63-CD43-FDAE0F01AD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8870A-62C8-401A-A287-C48EFB6166E6}" type="datetimeFigureOut">
              <a:rPr lang="en-GB" smtClean="0"/>
              <a:t>10/0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438996-D777-F7E9-4C34-6D4D2579BE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3CF821-17F0-B0CC-405B-473D7D0D77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F8FDF-581F-4595-A88C-F9E44F4712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11531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9111FF-7A0A-EE0A-E03F-53AB621029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282700"/>
            <a:ext cx="7886700" cy="2139950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91FB2E-9830-F8C1-2D6C-D222D05D5D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3441700"/>
            <a:ext cx="7886700" cy="1125538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702686-1CBE-81F0-1BDA-EA56C8ACB8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8870A-62C8-401A-A287-C48EFB6166E6}" type="datetimeFigureOut">
              <a:rPr lang="en-GB" smtClean="0"/>
              <a:t>10/0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6B3758-3199-EF3B-BC7F-88A7F69E21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3A3AA1-8FE8-05A9-BBD2-2EF92A2B90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F8FDF-581F-4595-A88C-F9E44F4712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206463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C8BF7A-BCF1-B9DA-16E1-88CABF0B71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40F8CD-351D-907A-D78B-99A15B37CC1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370013"/>
            <a:ext cx="3867150" cy="32623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0866FEB-A40F-F269-4D00-42C008A139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48200" y="1370013"/>
            <a:ext cx="3867150" cy="32623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1C4FB1-721B-73F0-32FD-4E7AC2364C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8870A-62C8-401A-A287-C48EFB6166E6}" type="datetimeFigureOut">
              <a:rPr lang="en-GB" smtClean="0"/>
              <a:t>10/01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55340D-4EB3-D624-4F11-AF570B3FBB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173A5D-BCF8-0C88-FE30-43CA7BE7FC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F8FDF-581F-4595-A88C-F9E44F4712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7346209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B51E76-4C4B-5B0E-D97C-92D7F920AD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0238" y="274638"/>
            <a:ext cx="7886700" cy="9937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4C0E95-E95B-A482-D2ED-CB9CBD3BB0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30238" y="1260475"/>
            <a:ext cx="3868737" cy="6191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DCA862-12FA-5D51-00FE-F6A7C89C82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30238" y="1879600"/>
            <a:ext cx="3868737" cy="27622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F6847BF-C145-B512-B816-64BB381C4D4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260475"/>
            <a:ext cx="3887788" cy="6191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02160F0-3209-F012-EA88-7F72A70830C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1879600"/>
            <a:ext cx="3887788" cy="27622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311FC68-8D69-9B7A-A121-3C63E52827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8870A-62C8-401A-A287-C48EFB6166E6}" type="datetimeFigureOut">
              <a:rPr lang="en-GB" smtClean="0"/>
              <a:t>10/01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D047CEA-74F7-799C-E17A-9847E98A90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BD9C2F4-B36C-E64D-7767-1D38C07C76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F8FDF-581F-4595-A88C-F9E44F4712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274043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EC48A0-BBD6-EE09-6957-7C83719AB4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4DE061B-2609-F8A7-7DD3-15AA7599C0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8870A-62C8-401A-A287-C48EFB6166E6}" type="datetimeFigureOut">
              <a:rPr lang="en-GB" smtClean="0"/>
              <a:t>10/01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328E16F-4F21-1676-5CBD-7363F94B73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3B57814-4214-1B3E-B16D-2655099B23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F8FDF-581F-4595-A88C-F9E44F4712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296802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0AB31EA-5D2D-3D84-6461-AA57F7E988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8870A-62C8-401A-A287-C48EFB6166E6}" type="datetimeFigureOut">
              <a:rPr lang="en-GB" smtClean="0"/>
              <a:t>10/01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69C39DA-112C-6970-1DB5-7F6175428C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D1F0123-CA9B-5B46-4916-14FA89D9E3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F8FDF-581F-4595-A88C-F9E44F4712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1130322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E5444D-0B7F-CF82-5FD7-B5B2DD5F32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0238" y="342900"/>
            <a:ext cx="2949575" cy="120015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652AC4-1091-DB2B-8369-9B1D0262CED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788" y="741363"/>
            <a:ext cx="4629150" cy="36544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32C106E-A185-2B03-AC0F-0CA62A23A6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30238" y="1543050"/>
            <a:ext cx="2949575" cy="28590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7AA174C-3A28-3A6E-9247-281290063E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8870A-62C8-401A-A287-C48EFB6166E6}" type="datetimeFigureOut">
              <a:rPr lang="en-GB" smtClean="0"/>
              <a:t>10/01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8E4426-680F-59E2-538B-5994E0D241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143036-2BA3-16B1-3A7A-ECAFAA1831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F8FDF-581F-4595-A88C-F9E44F4712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9299086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0A2FF6-9048-39A4-845C-D9215B4F47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0238" y="342900"/>
            <a:ext cx="2949575" cy="120015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63E55E6-30BA-4170-F46F-FB3C66CF35F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788" y="741363"/>
            <a:ext cx="4629150" cy="36544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E83EAFD-BA15-6B57-5D19-C2D25D0A83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30238" y="1543050"/>
            <a:ext cx="2949575" cy="28590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03A67C-945F-3DFD-4512-DFCDCA49A8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8870A-62C8-401A-A287-C48EFB6166E6}" type="datetimeFigureOut">
              <a:rPr lang="en-GB" smtClean="0"/>
              <a:t>10/01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22D5D4-CAD3-E12D-7868-152C9A9390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267DAA-3D9A-3F79-0369-BFE26CE575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F8FDF-581F-4595-A88C-F9E44F4712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00513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1C4E36-7F18-B00F-417E-BA62EB0B91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415B136-A358-E2BE-1DA7-1B473A617D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26CDD3-8098-038D-BA56-C3E9616A04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8870A-62C8-401A-A287-C48EFB6166E6}" type="datetimeFigureOut">
              <a:rPr lang="en-GB" smtClean="0"/>
              <a:t>10/0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9B689B-2D69-A8D3-6F29-9A16D33E54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789ACA-D7BA-7781-53F4-A5612E7880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F8FDF-581F-4595-A88C-F9E44F4712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9170393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2020EA7-B6C5-C67C-5A42-E03D714C330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274638"/>
            <a:ext cx="1971675" cy="435768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D55C38D-726A-BDBF-5B17-DBCE97C416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274638"/>
            <a:ext cx="5762625" cy="435768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35BDB8-F2FF-44FE-6DCC-6E2CD1F537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8870A-62C8-401A-A287-C48EFB6166E6}" type="datetimeFigureOut">
              <a:rPr lang="en-GB" smtClean="0"/>
              <a:t>10/0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B1D192-CA9F-2D04-ECCD-06C881EBDF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937044-C90A-D8BB-7C7D-61DE278271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F8FDF-581F-4595-A88C-F9E44F4712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73660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3305176"/>
            <a:ext cx="7772400" cy="102155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180035"/>
            <a:ext cx="7772400" cy="112514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651E-7EAF-4611-B03E-7082763CB9BE}" type="datetimeFigureOut">
              <a:rPr lang="de-AT" smtClean="0"/>
              <a:t>10.01.2024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EAECF-7086-45B2-8874-828A8139E49C}" type="slidenum">
              <a:rPr lang="de-AT" smtClean="0"/>
              <a:t>‹#›</a:t>
            </a:fld>
            <a:endParaRPr lang="de-AT"/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5226B862-3C47-4293-AF46-3AD17CB81354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0" y="0"/>
            <a:ext cx="9144000" cy="714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399903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Visual abstract 2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375989" y="811147"/>
            <a:ext cx="7932704" cy="417215"/>
          </a:xfrm>
        </p:spPr>
        <p:txBody>
          <a:bodyPr>
            <a:noAutofit/>
          </a:bodyPr>
          <a:lstStyle>
            <a:lvl1pPr>
              <a:defRPr sz="1400" b="1" i="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de-AT" dirty="0"/>
              <a:t>Title of </a:t>
            </a:r>
            <a:r>
              <a:rPr lang="de-AT"/>
              <a:t>the article</a:t>
            </a:r>
            <a:r>
              <a:rPr lang="en-GB"/>
              <a:t>; </a:t>
            </a:r>
            <a:r>
              <a:rPr lang="de-AT"/>
              <a:t>Font Arial or Times New Roman, font size 14</a:t>
            </a:r>
            <a:endParaRPr lang="de-AT" dirty="0"/>
          </a:p>
        </p:txBody>
      </p:sp>
      <p:sp>
        <p:nvSpPr>
          <p:cNvPr id="18" name="Inhaltsplatzhalter 3">
            <a:extLst>
              <a:ext uri="{FF2B5EF4-FFF2-40B4-BE49-F238E27FC236}">
                <a16:creationId xmlns:a16="http://schemas.microsoft.com/office/drawing/2014/main" id="{0CA42E41-50EF-AD8C-236F-1A7004FC1370}"/>
              </a:ext>
            </a:extLst>
          </p:cNvPr>
          <p:cNvSpPr>
            <a:spLocks noGrp="1"/>
          </p:cNvSpPr>
          <p:nvPr>
            <p:ph sz="half" idx="12" hasCustomPrompt="1"/>
          </p:nvPr>
        </p:nvSpPr>
        <p:spPr>
          <a:xfrm>
            <a:off x="3228288" y="1301903"/>
            <a:ext cx="2687424" cy="3212369"/>
          </a:xfr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>
            <a:normAutofit/>
          </a:bodyPr>
          <a:lstStyle>
            <a:lvl1pPr marL="0" indent="0" algn="ctr">
              <a:buNone/>
              <a:defRPr sz="1400" b="0" i="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dirty="0"/>
              <a:t>Methods;</a:t>
            </a:r>
            <a:br>
              <a:rPr lang="en-GB" dirty="0"/>
            </a:br>
            <a:r>
              <a:rPr lang="en-GB" dirty="0"/>
              <a:t>image, table or graph - no text.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086D2C5-219B-56FA-7C58-4184F7922F7A}"/>
              </a:ext>
            </a:extLst>
          </p:cNvPr>
          <p:cNvSpPr txBox="1"/>
          <p:nvPr userDrawn="1"/>
        </p:nvSpPr>
        <p:spPr>
          <a:xfrm>
            <a:off x="407100" y="4591591"/>
            <a:ext cx="8341364" cy="500439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 Placeholder 22">
            <a:extLst>
              <a:ext uri="{FF2B5EF4-FFF2-40B4-BE49-F238E27FC236}">
                <a16:creationId xmlns:a16="http://schemas.microsoft.com/office/drawing/2014/main" id="{07D448DB-D114-5B7E-E2B7-1BCEE7478EAB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407101" y="4584285"/>
            <a:ext cx="8341364" cy="504056"/>
          </a:xfrm>
        </p:spPr>
        <p:txBody>
          <a:bodyPr>
            <a:noAutofit/>
          </a:bodyPr>
          <a:lstStyle>
            <a:lvl1pPr marL="0" indent="0">
              <a:buNone/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  <a:lvl4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en-US" dirty="0"/>
              <a:t>Key takeaways, max. </a:t>
            </a:r>
            <a:r>
              <a:rPr lang="en-US"/>
              <a:t>100 words; font Arial or Times New Roman, font size 12.</a:t>
            </a:r>
            <a:endParaRPr lang="en-GB" dirty="0"/>
          </a:p>
        </p:txBody>
      </p:sp>
      <p:sp>
        <p:nvSpPr>
          <p:cNvPr id="32" name="Inhaltsplatzhalter 3">
            <a:extLst>
              <a:ext uri="{FF2B5EF4-FFF2-40B4-BE49-F238E27FC236}">
                <a16:creationId xmlns:a16="http://schemas.microsoft.com/office/drawing/2014/main" id="{6D07B8F4-1FB8-A151-BAF9-56D62424E29D}"/>
              </a:ext>
            </a:extLst>
          </p:cNvPr>
          <p:cNvSpPr>
            <a:spLocks noGrp="1"/>
          </p:cNvSpPr>
          <p:nvPr>
            <p:ph sz="half" idx="17" hasCustomPrompt="1"/>
          </p:nvPr>
        </p:nvSpPr>
        <p:spPr>
          <a:xfrm>
            <a:off x="6049476" y="1301903"/>
            <a:ext cx="2687424" cy="3217911"/>
          </a:xfr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>
            <a:normAutofit/>
          </a:bodyPr>
          <a:lstStyle>
            <a:lvl1pPr marL="0" indent="0" algn="ctr">
              <a:buNone/>
              <a:defRPr sz="1400" b="0" i="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dirty="0"/>
              <a:t>Results; </a:t>
            </a:r>
            <a:br>
              <a:rPr lang="en-GB" dirty="0"/>
            </a:br>
            <a:r>
              <a:rPr lang="en-GB" dirty="0"/>
              <a:t>image, table or graph - no text.</a:t>
            </a:r>
          </a:p>
        </p:txBody>
      </p:sp>
      <p:pic>
        <p:nvPicPr>
          <p:cNvPr id="3" name="Grafik 4">
            <a:extLst>
              <a:ext uri="{FF2B5EF4-FFF2-40B4-BE49-F238E27FC236}">
                <a16:creationId xmlns:a16="http://schemas.microsoft.com/office/drawing/2014/main" id="{DEDB9F59-0E02-8BF5-F5AF-EA131CB0A662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689" b="9582"/>
          <a:stretch/>
        </p:blipFill>
        <p:spPr>
          <a:xfrm>
            <a:off x="0" y="0"/>
            <a:ext cx="9144000" cy="766708"/>
          </a:xfrm>
          <a:prstGeom prst="rect">
            <a:avLst/>
          </a:prstGeom>
        </p:spPr>
      </p:pic>
      <p:sp>
        <p:nvSpPr>
          <p:cNvPr id="5" name="Inhaltsplatzhalter 3">
            <a:extLst>
              <a:ext uri="{FF2B5EF4-FFF2-40B4-BE49-F238E27FC236}">
                <a16:creationId xmlns:a16="http://schemas.microsoft.com/office/drawing/2014/main" id="{B692876C-C3BB-1280-A485-B3206C37B7A6}"/>
              </a:ext>
            </a:extLst>
          </p:cNvPr>
          <p:cNvSpPr>
            <a:spLocks noGrp="1"/>
          </p:cNvSpPr>
          <p:nvPr>
            <p:ph sz="half" idx="18" hasCustomPrompt="1"/>
          </p:nvPr>
        </p:nvSpPr>
        <p:spPr>
          <a:xfrm>
            <a:off x="407100" y="1300139"/>
            <a:ext cx="2687424" cy="3212369"/>
          </a:xfr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>
            <a:normAutofit/>
          </a:bodyPr>
          <a:lstStyle>
            <a:lvl1pPr marL="0" indent="0" algn="ctr">
              <a:buNone/>
              <a:defRPr sz="1400" b="0" i="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lang="en-GB"/>
              <a:t>Study design/context; </a:t>
            </a:r>
            <a:br>
              <a:rPr lang="en-GB"/>
            </a:br>
            <a:r>
              <a:rPr lang="en-GB"/>
              <a:t>image, table or graph - no text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649865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900113"/>
            <a:ext cx="4038600" cy="254555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900113"/>
            <a:ext cx="4038600" cy="254555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651E-7EAF-4611-B03E-7082763CB9BE}" type="datetimeFigureOut">
              <a:rPr lang="de-AT" smtClean="0"/>
              <a:t>10.01.2024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EAECF-7086-45B2-8874-828A8139E49C}" type="slidenum">
              <a:rPr lang="de-AT" smtClean="0"/>
              <a:t>‹#›</a:t>
            </a:fld>
            <a:endParaRPr lang="de-AT"/>
          </a:p>
        </p:txBody>
      </p:sp>
      <p:pic>
        <p:nvPicPr>
          <p:cNvPr id="8" name="Grafik 7">
            <a:extLst>
              <a:ext uri="{FF2B5EF4-FFF2-40B4-BE49-F238E27FC236}">
                <a16:creationId xmlns:a16="http://schemas.microsoft.com/office/drawing/2014/main" id="{1B262051-D88F-4810-8224-A7A79E784FEF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0" y="0"/>
            <a:ext cx="9144000" cy="714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75589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Visual abstract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826217" y="822568"/>
            <a:ext cx="7491565" cy="417215"/>
          </a:xfrm>
        </p:spPr>
        <p:txBody>
          <a:bodyPr>
            <a:normAutofit/>
          </a:bodyPr>
          <a:lstStyle>
            <a:lvl1pPr>
              <a:defRPr sz="1600" b="1" i="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de-AT" dirty="0"/>
              <a:t>Title of </a:t>
            </a:r>
            <a:r>
              <a:rPr lang="de-AT"/>
              <a:t>the Article (Please Capitalize)</a:t>
            </a:r>
            <a:br>
              <a:rPr lang="de-AT"/>
            </a:br>
            <a:r>
              <a:rPr lang="de-AT"/>
              <a:t>Font Arial or Times New Roman, Font Size 16</a:t>
            </a:r>
            <a:endParaRPr lang="de-AT" dirty="0"/>
          </a:p>
        </p:txBody>
      </p:sp>
      <p:sp>
        <p:nvSpPr>
          <p:cNvPr id="4" name="Inhaltsplatzhalter 3"/>
          <p:cNvSpPr>
            <a:spLocks noGrp="1"/>
          </p:cNvSpPr>
          <p:nvPr>
            <p:ph sz="half" idx="2" hasCustomPrompt="1"/>
          </p:nvPr>
        </p:nvSpPr>
        <p:spPr>
          <a:xfrm>
            <a:off x="323529" y="1347976"/>
            <a:ext cx="2774648" cy="3167990"/>
          </a:xfrm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>
            <a:normAutofit/>
          </a:bodyPr>
          <a:lstStyle>
            <a:lvl1pPr marL="0" indent="0" algn="ctr">
              <a:buNone/>
              <a:defRPr sz="1400" b="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lang="en-GB" dirty="0"/>
              <a:t>Study design/context; </a:t>
            </a:r>
            <a:br>
              <a:rPr lang="en-GB" dirty="0"/>
            </a:br>
            <a:r>
              <a:rPr lang="en-GB" dirty="0"/>
              <a:t>image, table or graph - no text.</a:t>
            </a:r>
          </a:p>
          <a:p>
            <a:pPr lvl="0"/>
            <a:endParaRPr lang="en-GB" dirty="0"/>
          </a:p>
          <a:p>
            <a:pPr lvl="0"/>
            <a:endParaRPr lang="en-GB" dirty="0"/>
          </a:p>
          <a:p>
            <a:pPr lvl="0"/>
            <a:endParaRPr lang="en-GB" dirty="0"/>
          </a:p>
        </p:txBody>
      </p:sp>
      <p:pic>
        <p:nvPicPr>
          <p:cNvPr id="10" name="Grafik 9">
            <a:extLst>
              <a:ext uri="{FF2B5EF4-FFF2-40B4-BE49-F238E27FC236}">
                <a16:creationId xmlns:a16="http://schemas.microsoft.com/office/drawing/2014/main" id="{C1D4319F-5931-41A1-879D-316E4400E8A1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0" y="0"/>
            <a:ext cx="9144000" cy="714375"/>
          </a:xfrm>
          <a:prstGeom prst="rect">
            <a:avLst/>
          </a:prstGeom>
        </p:spPr>
      </p:pic>
      <p:sp>
        <p:nvSpPr>
          <p:cNvPr id="18" name="Inhaltsplatzhalter 3">
            <a:extLst>
              <a:ext uri="{FF2B5EF4-FFF2-40B4-BE49-F238E27FC236}">
                <a16:creationId xmlns:a16="http://schemas.microsoft.com/office/drawing/2014/main" id="{0CA42E41-50EF-AD8C-236F-1A7004FC1370}"/>
              </a:ext>
            </a:extLst>
          </p:cNvPr>
          <p:cNvSpPr>
            <a:spLocks noGrp="1"/>
          </p:cNvSpPr>
          <p:nvPr>
            <p:ph sz="half" idx="12" hasCustomPrompt="1"/>
          </p:nvPr>
        </p:nvSpPr>
        <p:spPr>
          <a:xfrm>
            <a:off x="3180720" y="1344358"/>
            <a:ext cx="2687424" cy="3164372"/>
          </a:xfrm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>
            <a:normAutofit/>
          </a:bodyPr>
          <a:lstStyle>
            <a:lvl1pPr marL="0" indent="0" algn="ctr">
              <a:buNone/>
              <a:defRPr sz="1400" b="0" i="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dirty="0"/>
              <a:t>Methods;</a:t>
            </a:r>
            <a:br>
              <a:rPr lang="en-GB" dirty="0"/>
            </a:br>
            <a:r>
              <a:rPr lang="en-GB" dirty="0"/>
              <a:t>image, table or graph - no text.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086D2C5-219B-56FA-7C58-4184F7922F7A}"/>
              </a:ext>
            </a:extLst>
          </p:cNvPr>
          <p:cNvSpPr txBox="1"/>
          <p:nvPr userDrawn="1"/>
        </p:nvSpPr>
        <p:spPr>
          <a:xfrm>
            <a:off x="323528" y="4591591"/>
            <a:ext cx="8424936" cy="500439"/>
          </a:xfrm>
          <a:prstGeom prst="rect">
            <a:avLst/>
          </a:prstGeom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 Placeholder 22">
            <a:extLst>
              <a:ext uri="{FF2B5EF4-FFF2-40B4-BE49-F238E27FC236}">
                <a16:creationId xmlns:a16="http://schemas.microsoft.com/office/drawing/2014/main" id="{07D448DB-D114-5B7E-E2B7-1BCEE7478EAB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323528" y="4587974"/>
            <a:ext cx="8424936" cy="504056"/>
          </a:xfrm>
        </p:spPr>
        <p:txBody>
          <a:bodyPr>
            <a:noAutofit/>
          </a:bodyPr>
          <a:lstStyle>
            <a:lvl1pPr marL="0" indent="0">
              <a:buNone/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  <a:lvl4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en-US" dirty="0"/>
              <a:t>Key takeaways, max. </a:t>
            </a:r>
            <a:r>
              <a:rPr lang="en-US"/>
              <a:t>100 words; font Arial or Times New Roman, font size 12.</a:t>
            </a:r>
            <a:endParaRPr lang="en-GB" dirty="0"/>
          </a:p>
        </p:txBody>
      </p:sp>
      <p:sp>
        <p:nvSpPr>
          <p:cNvPr id="32" name="Inhaltsplatzhalter 3">
            <a:extLst>
              <a:ext uri="{FF2B5EF4-FFF2-40B4-BE49-F238E27FC236}">
                <a16:creationId xmlns:a16="http://schemas.microsoft.com/office/drawing/2014/main" id="{6D07B8F4-1FB8-A151-BAF9-56D62424E29D}"/>
              </a:ext>
            </a:extLst>
          </p:cNvPr>
          <p:cNvSpPr>
            <a:spLocks noGrp="1"/>
          </p:cNvSpPr>
          <p:nvPr>
            <p:ph sz="half" idx="17" hasCustomPrompt="1"/>
          </p:nvPr>
        </p:nvSpPr>
        <p:spPr>
          <a:xfrm>
            <a:off x="5963280" y="1347976"/>
            <a:ext cx="2785184" cy="3164372"/>
          </a:xfrm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>
            <a:normAutofit/>
          </a:bodyPr>
          <a:lstStyle>
            <a:lvl1pPr marL="0" indent="0" algn="ctr">
              <a:buNone/>
              <a:defRPr sz="1400" b="0" i="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dirty="0"/>
              <a:t>Results; </a:t>
            </a:r>
            <a:br>
              <a:rPr lang="en-GB" dirty="0"/>
            </a:br>
            <a:r>
              <a:rPr lang="en-GB" dirty="0"/>
              <a:t>image, table or graph - no text.</a:t>
            </a:r>
          </a:p>
        </p:txBody>
      </p:sp>
    </p:spTree>
    <p:extLst>
      <p:ext uri="{BB962C8B-B14F-4D97-AF65-F5344CB8AC3E}">
        <p14:creationId xmlns:p14="http://schemas.microsoft.com/office/powerpoint/2010/main" val="36806124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651E-7EAF-4611-B03E-7082763CB9BE}" type="datetimeFigureOut">
              <a:rPr lang="de-AT" smtClean="0"/>
              <a:t>10.01.2024</a:t>
            </a:fld>
            <a:endParaRPr lang="de-AT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EAECF-7086-45B2-8874-828A8139E49C}" type="slidenum">
              <a:rPr lang="de-AT" smtClean="0"/>
              <a:t>‹#›</a:t>
            </a:fld>
            <a:endParaRPr lang="de-AT"/>
          </a:p>
        </p:txBody>
      </p:sp>
      <p:pic>
        <p:nvPicPr>
          <p:cNvPr id="6" name="Grafik 5">
            <a:extLst>
              <a:ext uri="{FF2B5EF4-FFF2-40B4-BE49-F238E27FC236}">
                <a16:creationId xmlns:a16="http://schemas.microsoft.com/office/drawing/2014/main" id="{E46DAD42-38FE-4B5F-9206-7AA1A96A6C5E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0" y="0"/>
            <a:ext cx="9144000" cy="714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818388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651E-7EAF-4611-B03E-7082763CB9BE}" type="datetimeFigureOut">
              <a:rPr lang="de-AT" smtClean="0"/>
              <a:t>10.01.2024</a:t>
            </a:fld>
            <a:endParaRPr lang="de-AT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EAECF-7086-45B2-8874-828A8139E49C}" type="slidenum">
              <a:rPr lang="de-AT" smtClean="0"/>
              <a:t>‹#›</a:t>
            </a:fld>
            <a:endParaRPr lang="de-AT"/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0F880BAF-25B5-4646-8688-EA8956BFA5C6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0" y="0"/>
            <a:ext cx="9144000" cy="714375"/>
          </a:xfrm>
          <a:prstGeom prst="rect">
            <a:avLst/>
          </a:prstGeom>
        </p:spPr>
      </p:pic>
      <p:sp>
        <p:nvSpPr>
          <p:cNvPr id="7" name="Content Placeholder 6">
            <a:extLst>
              <a:ext uri="{FF2B5EF4-FFF2-40B4-BE49-F238E27FC236}">
                <a16:creationId xmlns:a16="http://schemas.microsoft.com/office/drawing/2014/main" id="{28709548-1D12-D3C3-D1D3-A05D00077532}"/>
              </a:ext>
            </a:extLst>
          </p:cNvPr>
          <p:cNvSpPr>
            <a:spLocks noGrp="1"/>
          </p:cNvSpPr>
          <p:nvPr>
            <p:ph sz="quarter" idx="13"/>
          </p:nvPr>
        </p:nvSpPr>
        <p:spPr>
          <a:xfrm>
            <a:off x="336004" y="1566249"/>
            <a:ext cx="2375991" cy="2376090"/>
          </a:xfrm>
        </p:spPr>
        <p:txBody>
          <a:bodyPr/>
          <a:lstStyle>
            <a:lvl2pPr marL="457200" indent="0">
              <a:buNone/>
              <a:defRPr/>
            </a:lvl2pPr>
          </a:lstStyle>
          <a:p>
            <a:pPr lvl="1"/>
            <a:endParaRPr lang="en-GB" dirty="0"/>
          </a:p>
        </p:txBody>
      </p:sp>
      <p:sp>
        <p:nvSpPr>
          <p:cNvPr id="9" name="Content Placeholder 8">
            <a:extLst>
              <a:ext uri="{FF2B5EF4-FFF2-40B4-BE49-F238E27FC236}">
                <a16:creationId xmlns:a16="http://schemas.microsoft.com/office/drawing/2014/main" id="{6FCBF420-D80A-F620-3785-EDF7414D2C80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4140200" y="1563688"/>
            <a:ext cx="2159992" cy="237609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1" name="Content Placeholder 10">
            <a:extLst>
              <a:ext uri="{FF2B5EF4-FFF2-40B4-BE49-F238E27FC236}">
                <a16:creationId xmlns:a16="http://schemas.microsoft.com/office/drawing/2014/main" id="{277A478E-8FD0-4045-B60D-AB5602A3590F}"/>
              </a:ext>
            </a:extLst>
          </p:cNvPr>
          <p:cNvSpPr>
            <a:spLocks noGrp="1"/>
          </p:cNvSpPr>
          <p:nvPr>
            <p:ph sz="quarter" idx="15"/>
          </p:nvPr>
        </p:nvSpPr>
        <p:spPr>
          <a:xfrm>
            <a:off x="7035800" y="1492250"/>
            <a:ext cx="2000696" cy="26636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37310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154781"/>
            <a:ext cx="2057400" cy="329088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154781"/>
            <a:ext cx="6019800" cy="3290888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651E-7EAF-4611-B03E-7082763CB9BE}" type="datetimeFigureOut">
              <a:rPr lang="de-AT" smtClean="0"/>
              <a:t>10.01.2024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EAECF-7086-45B2-8874-828A8139E49C}" type="slidenum">
              <a:rPr lang="de-AT" smtClean="0"/>
              <a:t>‹#›</a:t>
            </a:fld>
            <a:endParaRPr lang="de-AT"/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3B9E0C24-FD84-433C-A9A1-212EAD67DB8B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0" y="0"/>
            <a:ext cx="9144000" cy="714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413203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0F9F99-4ECC-F833-4F4C-48DF4105111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841375"/>
            <a:ext cx="6858000" cy="17907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5E89398-C84F-EE84-A84A-259AB44FC9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2701925"/>
            <a:ext cx="6858000" cy="1241425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4C7CF7-B1FC-0B0F-FA18-3B9FD61538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8870A-62C8-401A-A287-C48EFB6166E6}" type="datetimeFigureOut">
              <a:rPr lang="en-GB" smtClean="0"/>
              <a:t>10/0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21A943-D657-D904-CDF3-9637054F13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32D954-76E4-1B8F-9A2B-A725DA5541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F8FDF-581F-4595-A88C-F9E44F4712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08785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6.xml"/><Relationship Id="rId3" Type="http://schemas.openxmlformats.org/officeDocument/2006/relationships/slideLayout" Target="../slideLayouts/slideLayout11.xml"/><Relationship Id="rId7" Type="http://schemas.openxmlformats.org/officeDocument/2006/relationships/slideLayout" Target="../slideLayouts/slideLayout15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0.xml"/><Relationship Id="rId1" Type="http://schemas.openxmlformats.org/officeDocument/2006/relationships/slideLayout" Target="../slideLayouts/slideLayout9.xml"/><Relationship Id="rId6" Type="http://schemas.openxmlformats.org/officeDocument/2006/relationships/slideLayout" Target="../slideLayouts/slideLayout14.xml"/><Relationship Id="rId11" Type="http://schemas.openxmlformats.org/officeDocument/2006/relationships/slideLayout" Target="../slideLayouts/slideLayout19.xml"/><Relationship Id="rId5" Type="http://schemas.openxmlformats.org/officeDocument/2006/relationships/slideLayout" Target="../slideLayouts/slideLayout13.xml"/><Relationship Id="rId10" Type="http://schemas.openxmlformats.org/officeDocument/2006/relationships/slideLayout" Target="../slideLayouts/slideLayout18.xml"/><Relationship Id="rId4" Type="http://schemas.openxmlformats.org/officeDocument/2006/relationships/slideLayout" Target="../slideLayouts/slideLayout12.xml"/><Relationship Id="rId9" Type="http://schemas.openxmlformats.org/officeDocument/2006/relationships/slideLayout" Target="../slideLayouts/slideLayout17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200151"/>
            <a:ext cx="8229600" cy="339447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E8651E-7EAF-4611-B03E-7082763CB9BE}" type="datetimeFigureOut">
              <a:rPr lang="de-AT" smtClean="0"/>
              <a:t>10.01.2024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4767263"/>
            <a:ext cx="2895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7EAECF-7086-45B2-8874-828A8139E49C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0880104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60" r:id="rId3"/>
    <p:sldLayoutId id="2147483652" r:id="rId4"/>
    <p:sldLayoutId id="2147483653" r:id="rId5"/>
    <p:sldLayoutId id="2147483654" r:id="rId6"/>
    <p:sldLayoutId id="2147483655" r:id="rId7"/>
    <p:sldLayoutId id="2147483659" r:id="rId8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74C2B73-8D31-0B3D-5757-0C9069A697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274638"/>
            <a:ext cx="7886700" cy="9937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08C774-8B38-4DDD-4A87-15C952954C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370013"/>
            <a:ext cx="7886700" cy="32623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AB6FFE-063B-FB81-CB50-1978DE73E07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4767263"/>
            <a:ext cx="2057400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F8870A-62C8-401A-A287-C48EFB6166E6}" type="datetimeFigureOut">
              <a:rPr lang="en-GB" smtClean="0"/>
              <a:t>10/0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1F326B-0497-555F-12BE-EE94CC60187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4767263"/>
            <a:ext cx="3086100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953077-2FC4-864B-5B9B-F656CA266CA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4767263"/>
            <a:ext cx="2057400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7F8FDF-581F-4595-A88C-F9E44F4712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32117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3.xml"/><Relationship Id="rId5" Type="http://schemas.openxmlformats.org/officeDocument/2006/relationships/image" Target="../media/image6.jpeg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E708E8-40D9-F214-0848-AB29327FAB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moval Method of a Supera interwoven stent invaginated during its implantation</a:t>
            </a:r>
            <a:br>
              <a:rPr lang="en-US" dirty="0"/>
            </a:br>
            <a:r>
              <a:rPr lang="en-US" dirty="0"/>
              <a:t> in endovascular procedure</a:t>
            </a:r>
            <a:endParaRPr lang="en-GB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913DD74-7EBB-014C-03B4-588511CDBF4B}"/>
              </a:ext>
            </a:extLst>
          </p:cNvPr>
          <p:cNvSpPr>
            <a:spLocks noGrp="1"/>
          </p:cNvSpPr>
          <p:nvPr>
            <p:ph type="body" sz="quarter" idx="14"/>
          </p:nvPr>
        </p:nvSpPr>
        <p:spPr/>
        <p:txBody>
          <a:bodyPr/>
          <a:lstStyle/>
          <a:p>
            <a:r>
              <a:rPr lang="en-US" dirty="0"/>
              <a:t>Our findings demonstrate a practical and easy approach to removing invaginated Supera stents from the body, relying on its special structural characteristics. </a:t>
            </a:r>
            <a:endParaRPr lang="en-GB" dirty="0"/>
          </a:p>
        </p:txBody>
      </p:sp>
      <p:pic>
        <p:nvPicPr>
          <p:cNvPr id="8" name="コンテンツ プレースホルダー 7">
            <a:extLst>
              <a:ext uri="{FF2B5EF4-FFF2-40B4-BE49-F238E27FC236}">
                <a16:creationId xmlns:a16="http://schemas.microsoft.com/office/drawing/2014/main" id="{1ABFE3E7-4106-00B7-D52C-00F73AADE97C}"/>
              </a:ext>
            </a:extLst>
          </p:cNvPr>
          <p:cNvPicPr>
            <a:picLocks noGrp="1" noChangeAspect="1"/>
          </p:cNvPicPr>
          <p:nvPr>
            <p:ph sz="half" idx="18"/>
          </p:nvPr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10" r="11623"/>
          <a:stretch/>
        </p:blipFill>
        <p:spPr>
          <a:xfrm>
            <a:off x="510113" y="1280853"/>
            <a:ext cx="2088232" cy="3213100"/>
          </a:xfrm>
        </p:spPr>
      </p:pic>
      <p:pic>
        <p:nvPicPr>
          <p:cNvPr id="18" name="コンテンツ プレースホルダー 17">
            <a:extLst>
              <a:ext uri="{FF2B5EF4-FFF2-40B4-BE49-F238E27FC236}">
                <a16:creationId xmlns:a16="http://schemas.microsoft.com/office/drawing/2014/main" id="{2D657A30-F822-E72C-EA50-7C815647D441}"/>
              </a:ext>
            </a:extLst>
          </p:cNvPr>
          <p:cNvPicPr>
            <a:picLocks noGrp="1" noChangeAspect="1"/>
          </p:cNvPicPr>
          <p:nvPr>
            <p:ph sz="half" idx="12"/>
          </p:nvPr>
        </p:nvPicPr>
        <p:blipFill rotWithShape="1">
          <a:blip r:embed="rId4"/>
          <a:srcRect l="61048" r="20419"/>
          <a:stretch/>
        </p:blipFill>
        <p:spPr>
          <a:xfrm>
            <a:off x="2777132" y="1268347"/>
            <a:ext cx="1824531" cy="3226981"/>
          </a:xfrm>
          <a:prstGeom prst="rect">
            <a:avLst/>
          </a:prstGeom>
        </p:spPr>
      </p:pic>
      <p:pic>
        <p:nvPicPr>
          <p:cNvPr id="12" name="コンテンツ プレースホルダー 11">
            <a:extLst>
              <a:ext uri="{FF2B5EF4-FFF2-40B4-BE49-F238E27FC236}">
                <a16:creationId xmlns:a16="http://schemas.microsoft.com/office/drawing/2014/main" id="{6D1FE773-9C74-AB43-22AD-7EFA4A0F7A2A}"/>
              </a:ext>
            </a:extLst>
          </p:cNvPr>
          <p:cNvPicPr>
            <a:picLocks noGrp="1" noChangeAspect="1"/>
          </p:cNvPicPr>
          <p:nvPr>
            <p:ph sz="half" idx="17"/>
          </p:nvPr>
        </p:nvPicPr>
        <p:blipFill rotWithShape="1">
          <a:blip r:embed="rId4"/>
          <a:srcRect l="81271" r="2066"/>
          <a:stretch/>
        </p:blipFill>
        <p:spPr>
          <a:xfrm>
            <a:off x="4780451" y="1275943"/>
            <a:ext cx="1645425" cy="3236798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D2934ADF-3145-2620-2D41-A5A29106AE5D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65" r="26165"/>
          <a:stretch/>
        </p:blipFill>
        <p:spPr>
          <a:xfrm>
            <a:off x="6588224" y="1274599"/>
            <a:ext cx="2066929" cy="3239485"/>
          </a:xfrm>
          <a:prstGeom prst="rect">
            <a:avLst/>
          </a:prstGeom>
          <a:ln w="25400">
            <a:solidFill>
              <a:schemeClr val="accent2"/>
            </a:solidFill>
          </a:ln>
        </p:spPr>
      </p:pic>
    </p:spTree>
    <p:extLst>
      <p:ext uri="{BB962C8B-B14F-4D97-AF65-F5344CB8AC3E}">
        <p14:creationId xmlns:p14="http://schemas.microsoft.com/office/powerpoint/2010/main" val="2792937881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1</TotalTime>
  <Words>41</Words>
  <Application>Microsoft Office PowerPoint</Application>
  <PresentationFormat>画面に合わせる (16:9)</PresentationFormat>
  <Paragraphs>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Larissa</vt:lpstr>
      <vt:lpstr>Custom Design</vt:lpstr>
      <vt:lpstr>Removal Method of a Supera interwoven stent invaginated during its implantation  in endovascular procedure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ilvia Prinz</dc:creator>
  <cp:lastModifiedBy>昌彦 藤原</cp:lastModifiedBy>
  <cp:revision>193</cp:revision>
  <dcterms:created xsi:type="dcterms:W3CDTF">2018-09-14T16:58:27Z</dcterms:created>
  <dcterms:modified xsi:type="dcterms:W3CDTF">2024-01-10T06:58:34Z</dcterms:modified>
</cp:coreProperties>
</file>